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Default Extension="png" ContentType="image/png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5" r:id="rId2"/>
    <p:sldId id="269" r:id="rId3"/>
    <p:sldId id="257" r:id="rId4"/>
    <p:sldId id="258" r:id="rId5"/>
    <p:sldId id="259" r:id="rId6"/>
    <p:sldId id="266" r:id="rId7"/>
    <p:sldId id="267" r:id="rId8"/>
    <p:sldId id="262" r:id="rId9"/>
    <p:sldId id="268" r:id="rId10"/>
  </p:sldIdLst>
  <p:sldSz cx="9144000" cy="6858000" type="screen4x3"/>
  <p:notesSz cx="6797675" cy="9926638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 autoAdjust="0"/>
    <p:restoredTop sz="94612" autoAdjust="0"/>
  </p:normalViewPr>
  <p:slideViewPr>
    <p:cSldViewPr>
      <p:cViewPr>
        <p:scale>
          <a:sx n="100" d="100"/>
          <a:sy n="100" d="100"/>
        </p:scale>
        <p:origin x="-70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80" d="100"/>
          <a:sy n="80" d="100"/>
        </p:scale>
        <p:origin x="-2052" y="-102"/>
      </p:cViewPr>
      <p:guideLst>
        <p:guide orient="horz" pos="3127"/>
        <p:guide pos="2141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1ED081-C4F4-4552-94C0-519779D42F93}" type="datetimeFigureOut">
              <a:rPr lang="en-US" smtClean="0"/>
              <a:pPr/>
              <a:t>4/26/2013</a:t>
            </a:fld>
            <a:endParaRPr lang="en-US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14141C-E872-41F1-9035-842D659F6A2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847055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14141C-E872-41F1-9035-842D659F6A2D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245339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14141C-E872-41F1-9035-842D659F6A2D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5095012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14141C-E872-41F1-9035-842D659F6A2D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9281110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14141C-E872-41F1-9035-842D659F6A2D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890169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14141C-E872-41F1-9035-842D659F6A2D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30381829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14141C-E872-41F1-9035-842D659F6A2D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4226176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14141C-E872-41F1-9035-842D659F6A2D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7269372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14141C-E872-41F1-9035-842D659F6A2D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9283907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14141C-E872-41F1-9035-842D659F6A2D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277300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Faça clique para editar o estilo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7FCF06-0E8E-49AE-B376-30B6E6789E1A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2B77B-B775-4859-BE3A-FFEB277FF48F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F7835-744F-46CB-9263-918046A36A87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c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2E4EF-8FA9-483D-B043-D7A063F05E08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37456-40FD-44BD-B208-268A15436460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8C974-FE6C-4935-9F4C-92C859E6FCE6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5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6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7" name="Marcador de Posição d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B5E3-36AC-4FD0-8650-5A1CECC4CA1A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8" name="Marcador de Posição do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Posição do Número do Diapositivo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ECBD4-04C5-45B5-AD84-83862CDAE7E2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4" name="Marcador de Posição do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Posição do Número do Diapositivo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775FE-CE3A-4404-B255-6F5C5A880B15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3" name="Marcador de Posição do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36D4-95AD-4D52-A019-AB4C57907473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7D7B1-2557-4C6D-A03F-9C371DBCE27C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que para editar o estilo</a:t>
            </a:r>
            <a:endParaRPr lang="en-US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39D904-2D99-4D0E-801E-217A77523DB4}" type="datetime1">
              <a:rPr lang="en-US" smtClean="0"/>
              <a:pPr/>
              <a:t>4/26/2013</a:t>
            </a:fld>
            <a:endParaRPr lang="en-US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B69E74-BF3B-4550-B2E7-D5DC602379A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Marcador de Posição do Número do Diapositivo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1</a:t>
            </a:fld>
            <a:endParaRPr lang="en-US" dirty="0"/>
          </a:p>
        </p:txBody>
      </p:sp>
      <p:grpSp>
        <p:nvGrpSpPr>
          <p:cNvPr id="6" name="Grupo 5"/>
          <p:cNvGrpSpPr/>
          <p:nvPr/>
        </p:nvGrpSpPr>
        <p:grpSpPr>
          <a:xfrm>
            <a:off x="1115616" y="764704"/>
            <a:ext cx="7488832" cy="3688090"/>
            <a:chOff x="1115616" y="764704"/>
            <a:chExt cx="7488832" cy="3688090"/>
          </a:xfrm>
        </p:grpSpPr>
        <p:sp>
          <p:nvSpPr>
            <p:cNvPr id="4" name="CaixaDeTexto 3"/>
            <p:cNvSpPr txBox="1"/>
            <p:nvPr/>
          </p:nvSpPr>
          <p:spPr>
            <a:xfrm>
              <a:off x="3635896" y="764704"/>
              <a:ext cx="2563522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Times New Roman" pitchFamily="18" charset="0"/>
                  <a:cs typeface="Times New Roman" pitchFamily="18" charset="0"/>
                </a:rPr>
                <a:t>Supporting Information</a:t>
              </a:r>
            </a:p>
            <a:p>
              <a:endParaRPr lang="en-US" b="1" i="1" dirty="0" smtClean="0">
                <a:latin typeface="Arial" pitchFamily="34" charset="0"/>
                <a:cs typeface="Arial" pitchFamily="34" charset="0"/>
              </a:endParaRPr>
            </a:p>
            <a:p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CaixaDeTexto 4"/>
            <p:cNvSpPr txBox="1"/>
            <p:nvPr/>
          </p:nvSpPr>
          <p:spPr>
            <a:xfrm>
              <a:off x="1115616" y="2636912"/>
              <a:ext cx="4719818" cy="18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Figure S1. 	</a:t>
              </a:r>
              <a:r>
                <a:rPr lang="en-US" sz="1400" baseline="30000" dirty="0" smtClean="0">
                  <a:latin typeface="Times New Roman" pitchFamily="18" charset="0"/>
                  <a:cs typeface="Times New Roman" pitchFamily="18" charset="0"/>
                </a:rPr>
                <a:t>1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H-NMR spectrum of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9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recorded in </a:t>
              </a:r>
              <a:r>
                <a:rPr lang="en-US" sz="1400" dirty="0" err="1" smtClean="0">
                  <a:latin typeface="Times New Roman" pitchFamily="18" charset="0"/>
                  <a:cs typeface="Times New Roman" pitchFamily="18" charset="0"/>
                </a:rPr>
                <a:t>MeOD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</a:p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Figure S2. 	</a:t>
              </a:r>
              <a:r>
                <a:rPr lang="en-US" sz="1400" baseline="30000" dirty="0" smtClean="0">
                  <a:latin typeface="Times New Roman" pitchFamily="18" charset="0"/>
                  <a:cs typeface="Times New Roman" pitchFamily="18" charset="0"/>
                </a:rPr>
                <a:t>13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C-NMR spectrum of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9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 recorded in </a:t>
              </a:r>
              <a:r>
                <a:rPr lang="en-US" sz="1400" dirty="0" err="1" smtClean="0">
                  <a:latin typeface="Times New Roman" pitchFamily="18" charset="0"/>
                  <a:cs typeface="Times New Roman" pitchFamily="18" charset="0"/>
                </a:rPr>
                <a:t>MeOD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</a:p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Figure S3. 	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HSQC</a:t>
              </a:r>
              <a:r>
                <a:rPr lang="en-US" sz="1400" baseline="30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spectrum</a:t>
              </a:r>
              <a:r>
                <a:rPr lang="en-US" sz="1400" baseline="30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of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9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recorded in </a:t>
              </a:r>
              <a:r>
                <a:rPr lang="en-US" sz="1400" dirty="0" err="1" smtClean="0">
                  <a:latin typeface="Times New Roman" pitchFamily="18" charset="0"/>
                  <a:cs typeface="Times New Roman" pitchFamily="18" charset="0"/>
                </a:rPr>
                <a:t>MeOD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</a:p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Figure S4. 	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HMBC</a:t>
              </a:r>
              <a:r>
                <a:rPr lang="en-US" sz="1400" baseline="30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spectrum</a:t>
              </a:r>
              <a:r>
                <a:rPr lang="en-US" sz="1400" baseline="30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of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9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recorded in </a:t>
              </a:r>
              <a:r>
                <a:rPr lang="en-US" sz="1400" dirty="0" err="1" smtClean="0">
                  <a:latin typeface="Times New Roman" pitchFamily="18" charset="0"/>
                  <a:cs typeface="Times New Roman" pitchFamily="18" charset="0"/>
                </a:rPr>
                <a:t>MeOD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</a:p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Figure S5. 	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ESI-MS spectrum of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9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</a:p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Figure S6. 	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Tandem ESI-MS spectra of  the 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m/z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 507 ion of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9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</a:p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Figure S7. 	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HPLC-DAD of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9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recorded at 254 nm.</a:t>
              </a:r>
            </a:p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Figure S8.	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Tandem ESI-MS spectra of  the </a:t>
              </a:r>
              <a:r>
                <a:rPr lang="en-US" sz="1400" i="1" dirty="0" smtClean="0">
                  <a:latin typeface="Times New Roman" pitchFamily="18" charset="0"/>
                  <a:cs typeface="Times New Roman" pitchFamily="18" charset="0"/>
                </a:rPr>
                <a:t>m/z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 507 ion of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  <a:endParaRPr 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85" name="Rectangle 1"/>
            <p:cNvSpPr>
              <a:spLocks noChangeArrowheads="1"/>
            </p:cNvSpPr>
            <p:nvPr/>
          </p:nvSpPr>
          <p:spPr bwMode="auto">
            <a:xfrm>
              <a:off x="1115616" y="1380348"/>
              <a:ext cx="7488832" cy="954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eaLnBrk="0" hangingPunct="0"/>
              <a:r>
                <a:rPr lang="en-US" b="1" dirty="0" smtClean="0">
                  <a:latin typeface="Times New Roman" pitchFamily="18" charset="0"/>
                  <a:cs typeface="Times New Roman" pitchFamily="18" charset="0"/>
                </a:rPr>
                <a:t>2'-Deoxythymidine Adducts from the Anti-HIV Drug </a:t>
              </a:r>
              <a:r>
                <a:rPr lang="en-US" b="1" dirty="0" err="1" smtClean="0">
                  <a:latin typeface="Times New Roman" pitchFamily="18" charset="0"/>
                  <a:cs typeface="Times New Roman" pitchFamily="18" charset="0"/>
                </a:rPr>
                <a:t>Nevirapine</a:t>
              </a:r>
              <a:endParaRPr lang="en-US" b="1" dirty="0" smtClean="0">
                <a:latin typeface="Times New Roman" pitchFamily="18" charset="0"/>
                <a:cs typeface="Times New Roman" pitchFamily="18" charset="0"/>
              </a:endParaRPr>
            </a:p>
            <a:p>
              <a:pPr marL="0" marR="0" lvl="0" indent="0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pt-PT" altLang="ja-JP" sz="14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MS Mincho" pitchFamily="49" charset="-128"/>
                <a:cs typeface="Arial" pitchFamily="34" charset="0"/>
              </a:endParaRP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pt-PT" altLang="ja-JP" sz="1200" b="1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MS Mincho" pitchFamily="49" charset="-128"/>
                  <a:cs typeface="Times New Roman" pitchFamily="18" charset="0"/>
                </a:rPr>
                <a:t>Alexandra M. M. Antunes </a:t>
              </a:r>
              <a:r>
                <a:rPr lang="pt-PT" altLang="ja-JP" sz="1200" b="1" dirty="0" smtClean="0">
                  <a:latin typeface="Times New Roman" pitchFamily="18" charset="0"/>
                  <a:ea typeface="MS Mincho" pitchFamily="49" charset="-128"/>
                  <a:cs typeface="Times New Roman" pitchFamily="18" charset="0"/>
                </a:rPr>
                <a:t>*, </a:t>
              </a:r>
              <a:r>
                <a:rPr kumimoji="0" lang="pt-PT" altLang="ja-JP" sz="1200" b="1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MS Mincho" pitchFamily="49" charset="-128"/>
                  <a:cs typeface="Times New Roman" pitchFamily="18" charset="0"/>
                </a:rPr>
                <a:t>Benjamin Wolf, M. Conceição Oliveira, </a:t>
              </a:r>
              <a:r>
                <a:rPr kumimoji="0" lang="pt-PT" altLang="ja-JP" sz="1200" b="1" u="none" strike="noStrike" cap="none" normalizeH="0" baseline="0" dirty="0" err="1" smtClean="0">
                  <a:ln>
                    <a:noFill/>
                  </a:ln>
                  <a:effectLst/>
                  <a:latin typeface="Times New Roman" pitchFamily="18" charset="0"/>
                  <a:ea typeface="MS Mincho" pitchFamily="49" charset="-128"/>
                  <a:cs typeface="Times New Roman" pitchFamily="18" charset="0"/>
                </a:rPr>
                <a:t>Frederick</a:t>
              </a:r>
              <a:r>
                <a:rPr kumimoji="0" lang="pt-PT" altLang="ja-JP" sz="1200" b="1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MS Mincho" pitchFamily="49" charset="-128"/>
                  <a:cs typeface="Times New Roman" pitchFamily="18" charset="0"/>
                </a:rPr>
                <a:t> A. Beland and </a:t>
              </a:r>
              <a:br>
                <a:rPr kumimoji="0" lang="pt-PT" altLang="ja-JP" sz="1200" b="1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MS Mincho" pitchFamily="49" charset="-128"/>
                  <a:cs typeface="Times New Roman" pitchFamily="18" charset="0"/>
                </a:rPr>
              </a:br>
              <a:r>
                <a:rPr kumimoji="0" lang="pt-PT" altLang="ja-JP" sz="1200" b="1" u="none" strike="noStrike" cap="none" normalizeH="0" baseline="0" dirty="0" smtClean="0">
                  <a:ln>
                    <a:noFill/>
                  </a:ln>
                  <a:effectLst/>
                  <a:latin typeface="Times New Roman" pitchFamily="18" charset="0"/>
                  <a:ea typeface="MS Mincho" pitchFamily="49" charset="-128"/>
                  <a:cs typeface="Times New Roman" pitchFamily="18" charset="0"/>
                </a:rPr>
                <a:t>M. Matilde Marques *</a:t>
              </a:r>
              <a:endParaRPr kumimoji="0" lang="pt-PT" altLang="ja-JP" sz="1200" b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032533" y="786190"/>
            <a:ext cx="6851835" cy="4792597"/>
            <a:chOff x="1032533" y="786190"/>
            <a:chExt cx="6851835" cy="4792597"/>
          </a:xfrm>
        </p:grpSpPr>
        <p:sp>
          <p:nvSpPr>
            <p:cNvPr id="6" name="CaixaDeTexto 5"/>
            <p:cNvSpPr txBox="1"/>
            <p:nvPr/>
          </p:nvSpPr>
          <p:spPr>
            <a:xfrm>
              <a:off x="2051720" y="786190"/>
              <a:ext cx="472225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itchFamily="18" charset="0"/>
                  <a:cs typeface="Times New Roman" pitchFamily="18" charset="0"/>
                </a:rPr>
                <a:t>Figure S1. </a:t>
              </a:r>
              <a:r>
                <a:rPr lang="en-US" sz="1600" baseline="30000" dirty="0" smtClean="0">
                  <a:latin typeface="Times New Roman" pitchFamily="18" charset="0"/>
                  <a:cs typeface="Times New Roman" pitchFamily="18" charset="0"/>
                </a:rPr>
                <a:t>1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H-NMR spectrum of </a:t>
              </a:r>
              <a:r>
                <a:rPr lang="en-US" sz="1600" b="1" dirty="0" smtClean="0">
                  <a:latin typeface="Times New Roman" pitchFamily="18" charset="0"/>
                  <a:cs typeface="Times New Roman" pitchFamily="18" charset="0"/>
                </a:rPr>
                <a:t>9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recorded in </a:t>
              </a:r>
              <a:r>
                <a:rPr lang="en-US" sz="1600" dirty="0" err="1" smtClean="0">
                  <a:latin typeface="Times New Roman" pitchFamily="18" charset="0"/>
                  <a:cs typeface="Times New Roman" pitchFamily="18" charset="0"/>
                </a:rPr>
                <a:t>MeOD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1032533" y="1534641"/>
              <a:ext cx="6851835" cy="4044146"/>
              <a:chOff x="1176549" y="1534641"/>
              <a:chExt cx="6851835" cy="4044146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1403648" y="1534641"/>
                <a:ext cx="6624736" cy="4044146"/>
                <a:chOff x="1403648" y="1534641"/>
                <a:chExt cx="6624736" cy="4044146"/>
              </a:xfrm>
            </p:grpSpPr>
            <p:grpSp>
              <p:nvGrpSpPr>
                <p:cNvPr id="4105" name="Group 4104"/>
                <p:cNvGrpSpPr/>
                <p:nvPr/>
              </p:nvGrpSpPr>
              <p:grpSpPr>
                <a:xfrm>
                  <a:off x="2028322" y="5301788"/>
                  <a:ext cx="5519404" cy="276999"/>
                  <a:chOff x="2028322" y="5301788"/>
                  <a:chExt cx="5519404" cy="276999"/>
                </a:xfrm>
              </p:grpSpPr>
              <p:sp>
                <p:nvSpPr>
                  <p:cNvPr id="22" name="TextBox 21"/>
                  <p:cNvSpPr txBox="1"/>
                  <p:nvPr/>
                </p:nvSpPr>
                <p:spPr>
                  <a:xfrm>
                    <a:off x="2676394" y="5301788"/>
                    <a:ext cx="383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t-PT" sz="1200" b="1" dirty="0" smtClean="0"/>
                      <a:t>7.0</a:t>
                    </a:r>
                    <a:endParaRPr lang="pt-PT" sz="1200" b="1" dirty="0"/>
                  </a:p>
                </p:txBody>
              </p:sp>
              <p:sp>
                <p:nvSpPr>
                  <p:cNvPr id="21" name="TextBox 20"/>
                  <p:cNvSpPr txBox="1"/>
                  <p:nvPr/>
                </p:nvSpPr>
                <p:spPr>
                  <a:xfrm>
                    <a:off x="2028322" y="5301788"/>
                    <a:ext cx="383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t-PT" sz="1200" b="1" dirty="0" smtClean="0"/>
                      <a:t>8.0</a:t>
                    </a:r>
                    <a:endParaRPr lang="pt-PT" sz="1200" b="1" dirty="0"/>
                  </a:p>
                </p:txBody>
              </p:sp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3324466" y="5301788"/>
                    <a:ext cx="383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t-PT" sz="1200" b="1" dirty="0" smtClean="0"/>
                      <a:t>6.0</a:t>
                    </a:r>
                    <a:endParaRPr lang="pt-PT" sz="1200" b="1" dirty="0"/>
                  </a:p>
                </p:txBody>
              </p:sp>
              <p:sp>
                <p:nvSpPr>
                  <p:cNvPr id="24" name="TextBox 23"/>
                  <p:cNvSpPr txBox="1"/>
                  <p:nvPr/>
                </p:nvSpPr>
                <p:spPr>
                  <a:xfrm>
                    <a:off x="3972538" y="5301788"/>
                    <a:ext cx="383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t-PT" sz="1200" b="1" dirty="0" smtClean="0"/>
                      <a:t>5.0</a:t>
                    </a:r>
                    <a:endParaRPr lang="pt-PT" sz="1200" b="1" dirty="0"/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4620610" y="5301788"/>
                    <a:ext cx="383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t-PT" sz="1200" b="1" dirty="0" smtClean="0"/>
                      <a:t>4.0</a:t>
                    </a:r>
                    <a:endParaRPr lang="pt-PT" sz="1200" b="1" dirty="0"/>
                  </a:p>
                </p:txBody>
              </p:sp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5268682" y="5301788"/>
                    <a:ext cx="383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t-PT" sz="1200" b="1" dirty="0" smtClean="0"/>
                      <a:t>3.0</a:t>
                    </a:r>
                    <a:endParaRPr lang="pt-PT" sz="1200" b="1" dirty="0"/>
                  </a:p>
                </p:txBody>
              </p:sp>
              <p:sp>
                <p:nvSpPr>
                  <p:cNvPr id="27" name="TextBox 26"/>
                  <p:cNvSpPr txBox="1"/>
                  <p:nvPr/>
                </p:nvSpPr>
                <p:spPr>
                  <a:xfrm>
                    <a:off x="5916754" y="5301788"/>
                    <a:ext cx="383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t-PT" sz="1200" b="1" dirty="0" smtClean="0"/>
                      <a:t>2.0</a:t>
                    </a:r>
                    <a:endParaRPr lang="pt-PT" sz="1200" b="1" dirty="0"/>
                  </a:p>
                </p:txBody>
              </p:sp>
              <p:sp>
                <p:nvSpPr>
                  <p:cNvPr id="28" name="TextBox 27"/>
                  <p:cNvSpPr txBox="1"/>
                  <p:nvPr/>
                </p:nvSpPr>
                <p:spPr>
                  <a:xfrm>
                    <a:off x="6564826" y="5301788"/>
                    <a:ext cx="383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t-PT" sz="1200" b="1" dirty="0" smtClean="0"/>
                      <a:t>1.0</a:t>
                    </a:r>
                    <a:endParaRPr lang="pt-PT" sz="1200" b="1" dirty="0"/>
                  </a:p>
                </p:txBody>
              </p:sp>
              <p:sp>
                <p:nvSpPr>
                  <p:cNvPr id="29" name="TextBox 28"/>
                  <p:cNvSpPr txBox="1"/>
                  <p:nvPr/>
                </p:nvSpPr>
                <p:spPr>
                  <a:xfrm>
                    <a:off x="7164288" y="5301788"/>
                    <a:ext cx="38343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pt-PT" sz="1200" b="1" dirty="0" smtClean="0"/>
                      <a:t>0.0</a:t>
                    </a:r>
                    <a:endParaRPr lang="pt-PT" sz="1200" b="1" dirty="0"/>
                  </a:p>
                </p:txBody>
              </p:sp>
            </p:grpSp>
            <p:sp>
              <p:nvSpPr>
                <p:cNvPr id="4106" name="TextBox 4105"/>
                <p:cNvSpPr txBox="1"/>
                <p:nvPr/>
              </p:nvSpPr>
              <p:spPr>
                <a:xfrm>
                  <a:off x="7452585" y="5301788"/>
                  <a:ext cx="57579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PT" sz="1200" b="1" dirty="0" smtClean="0"/>
                    <a:t>[</a:t>
                  </a:r>
                  <a:r>
                    <a:rPr lang="pt-PT" sz="1200" b="1" dirty="0" err="1" smtClean="0"/>
                    <a:t>ppm</a:t>
                  </a:r>
                  <a:r>
                    <a:rPr lang="pt-PT" sz="1200" b="1" dirty="0" smtClean="0"/>
                    <a:t>]</a:t>
                  </a:r>
                  <a:endParaRPr lang="pt-PT" sz="1200" b="1" dirty="0"/>
                </a:p>
              </p:txBody>
            </p:sp>
            <p:sp>
              <p:nvSpPr>
                <p:cNvPr id="4114" name="Rectangle 4113"/>
                <p:cNvSpPr/>
                <p:nvPr/>
              </p:nvSpPr>
              <p:spPr>
                <a:xfrm>
                  <a:off x="6084433" y="3043699"/>
                  <a:ext cx="503791" cy="16927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PT"/>
                </a:p>
              </p:txBody>
            </p:sp>
            <p:pic>
              <p:nvPicPr>
                <p:cNvPr id="1028" name="Picture 4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=""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403648" y="1534641"/>
                  <a:ext cx="6096000" cy="38385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33" name="Group 32"/>
              <p:cNvGrpSpPr/>
              <p:nvPr/>
            </p:nvGrpSpPr>
            <p:grpSpPr>
              <a:xfrm>
                <a:off x="1176549" y="1534641"/>
                <a:ext cx="2571750" cy="1706706"/>
                <a:chOff x="1077275" y="1506270"/>
                <a:chExt cx="2571750" cy="1706706"/>
              </a:xfrm>
            </p:grpSpPr>
            <p:pic>
              <p:nvPicPr>
                <p:cNvPr id="34" name="Picture 7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=""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077275" y="1506270"/>
                  <a:ext cx="2571750" cy="14763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35" name="TextBox 34"/>
                <p:cNvSpPr txBox="1"/>
                <p:nvPr/>
              </p:nvSpPr>
              <p:spPr>
                <a:xfrm>
                  <a:off x="2122898" y="2874422"/>
                  <a:ext cx="28886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pt-PT" sz="1600" b="1" dirty="0" smtClean="0"/>
                    <a:t>9</a:t>
                  </a:r>
                  <a:endParaRPr lang="pt-PT" sz="1600" b="1" dirty="0"/>
                </a:p>
              </p:txBody>
            </p:sp>
          </p:grpSp>
        </p:grpSp>
      </p:grp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167926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Marcador de Posição do Número do Diapositivo 3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3</a:t>
            </a:fld>
            <a:endParaRPr lang="en-US"/>
          </a:p>
        </p:txBody>
      </p:sp>
      <p:grpSp>
        <p:nvGrpSpPr>
          <p:cNvPr id="13" name="Group 12"/>
          <p:cNvGrpSpPr/>
          <p:nvPr/>
        </p:nvGrpSpPr>
        <p:grpSpPr>
          <a:xfrm>
            <a:off x="714348" y="714356"/>
            <a:ext cx="8208912" cy="4267944"/>
            <a:chOff x="467544" y="1268760"/>
            <a:chExt cx="8208912" cy="4267944"/>
          </a:xfrm>
        </p:grpSpPr>
        <p:sp>
          <p:nvSpPr>
            <p:cNvPr id="5" name="CaixaDeTexto 4"/>
            <p:cNvSpPr txBox="1"/>
            <p:nvPr/>
          </p:nvSpPr>
          <p:spPr>
            <a:xfrm>
              <a:off x="1835696" y="1268760"/>
              <a:ext cx="477996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itchFamily="18" charset="0"/>
                  <a:cs typeface="Times New Roman" pitchFamily="18" charset="0"/>
                </a:rPr>
                <a:t>Figure S2. </a:t>
              </a:r>
              <a:r>
                <a:rPr lang="en-US" sz="1600" baseline="30000" dirty="0" smtClean="0">
                  <a:latin typeface="Times New Roman" pitchFamily="18" charset="0"/>
                  <a:cs typeface="Times New Roman" pitchFamily="18" charset="0"/>
                </a:rPr>
                <a:t>13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C-NMR spectrum of </a:t>
              </a:r>
              <a:r>
                <a:rPr lang="en-US" sz="1600" b="1" dirty="0" smtClean="0">
                  <a:latin typeface="Times New Roman" pitchFamily="18" charset="0"/>
                  <a:cs typeface="Times New Roman" pitchFamily="18" charset="0"/>
                </a:rPr>
                <a:t>9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 recorded in </a:t>
              </a:r>
              <a:r>
                <a:rPr lang="en-US" sz="1600" dirty="0" err="1" smtClean="0">
                  <a:latin typeface="Times New Roman" pitchFamily="18" charset="0"/>
                  <a:cs typeface="Times New Roman" pitchFamily="18" charset="0"/>
                </a:rPr>
                <a:t>MeOD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64" name="Grupo 63"/>
            <p:cNvGrpSpPr/>
            <p:nvPr/>
          </p:nvGrpSpPr>
          <p:grpSpPr>
            <a:xfrm>
              <a:off x="467544" y="2564904"/>
              <a:ext cx="8208912" cy="2971800"/>
              <a:chOff x="467544" y="2564904"/>
              <a:chExt cx="8208912" cy="2971800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958229" y="2564904"/>
                <a:ext cx="7142163" cy="2971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" name="CaixaDeTexto 3"/>
              <p:cNvSpPr txBox="1"/>
              <p:nvPr/>
            </p:nvSpPr>
            <p:spPr>
              <a:xfrm>
                <a:off x="539552" y="4694947"/>
                <a:ext cx="6110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6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" name="CaixaDeTexto 5"/>
              <p:cNvSpPr txBox="1"/>
              <p:nvPr/>
            </p:nvSpPr>
            <p:spPr>
              <a:xfrm>
                <a:off x="467544" y="4550931"/>
                <a:ext cx="79380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dTC4+C4*</a:t>
                </a:r>
                <a:endParaRPr lang="en-US" sz="1000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8" name="Conexão recta unidireccional 7"/>
              <p:cNvCxnSpPr/>
              <p:nvPr/>
            </p:nvCxnSpPr>
            <p:spPr>
              <a:xfrm>
                <a:off x="1187624" y="4725144"/>
                <a:ext cx="0" cy="216024"/>
              </a:xfrm>
              <a:prstGeom prst="straightConnector1">
                <a:avLst/>
              </a:prstGeom>
              <a:ln>
                <a:solidFill>
                  <a:srgbClr val="00B0F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CaixaDeTexto 9"/>
              <p:cNvSpPr txBox="1"/>
              <p:nvPr/>
            </p:nvSpPr>
            <p:spPr>
              <a:xfrm>
                <a:off x="2266533" y="4694947"/>
                <a:ext cx="7008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dTC6+6*</a:t>
                </a:r>
                <a:endParaRPr lang="en-US" sz="1000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CaixaDeTexto 11"/>
              <p:cNvSpPr txBox="1"/>
              <p:nvPr/>
            </p:nvSpPr>
            <p:spPr>
              <a:xfrm>
                <a:off x="755576" y="4406915"/>
                <a:ext cx="7521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10a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CaixaDeTexto 14"/>
              <p:cNvSpPr txBox="1"/>
              <p:nvPr/>
            </p:nvSpPr>
            <p:spPr>
              <a:xfrm>
                <a:off x="899592" y="4046875"/>
                <a:ext cx="127310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9 + </a:t>
                </a:r>
                <a:r>
                  <a:rPr lang="en-US" sz="1000" b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dTC2+2*</a:t>
                </a:r>
                <a:endParaRPr lang="en-US" sz="1000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9" name="Conexão recta unidireccional 18"/>
              <p:cNvCxnSpPr/>
              <p:nvPr/>
            </p:nvCxnSpPr>
            <p:spPr>
              <a:xfrm>
                <a:off x="1331640" y="4581128"/>
                <a:ext cx="72008" cy="216024"/>
              </a:xfrm>
              <a:prstGeom prst="straightConnector1">
                <a:avLst/>
              </a:prstGeom>
              <a:ln>
                <a:solidFill>
                  <a:srgbClr val="92D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CaixaDeTexto 23"/>
              <p:cNvSpPr txBox="1"/>
              <p:nvPr/>
            </p:nvSpPr>
            <p:spPr>
              <a:xfrm>
                <a:off x="867543" y="4262899"/>
                <a:ext cx="7521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11a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6" name="Conexão recta unidireccional 25"/>
              <p:cNvCxnSpPr/>
              <p:nvPr/>
            </p:nvCxnSpPr>
            <p:spPr>
              <a:xfrm>
                <a:off x="1475656" y="4437112"/>
                <a:ext cx="72008" cy="288032"/>
              </a:xfrm>
              <a:prstGeom prst="straightConnector1">
                <a:avLst/>
              </a:prstGeom>
              <a:ln>
                <a:solidFill>
                  <a:srgbClr val="92D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exão recta unidireccional 27"/>
              <p:cNvCxnSpPr/>
              <p:nvPr/>
            </p:nvCxnSpPr>
            <p:spPr>
              <a:xfrm>
                <a:off x="1763688" y="4293096"/>
                <a:ext cx="0" cy="432048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CaixaDeTexto 29"/>
              <p:cNvSpPr txBox="1"/>
              <p:nvPr/>
            </p:nvSpPr>
            <p:spPr>
              <a:xfrm>
                <a:off x="1728687" y="4478923"/>
                <a:ext cx="6110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2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CaixaDeTexto 30"/>
              <p:cNvSpPr txBox="1"/>
              <p:nvPr/>
            </p:nvSpPr>
            <p:spPr>
              <a:xfrm>
                <a:off x="2088727" y="4334907"/>
                <a:ext cx="6110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7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CaixaDeTexto 31"/>
              <p:cNvSpPr txBox="1"/>
              <p:nvPr/>
            </p:nvSpPr>
            <p:spPr>
              <a:xfrm>
                <a:off x="2195736" y="4550931"/>
                <a:ext cx="6110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4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CaixaDeTexto 33"/>
              <p:cNvSpPr txBox="1"/>
              <p:nvPr/>
            </p:nvSpPr>
            <p:spPr>
              <a:xfrm>
                <a:off x="2448767" y="4437112"/>
                <a:ext cx="6815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4a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8" name="Conexão recta unidireccional 37"/>
              <p:cNvCxnSpPr/>
              <p:nvPr/>
            </p:nvCxnSpPr>
            <p:spPr>
              <a:xfrm>
                <a:off x="2915816" y="4581128"/>
                <a:ext cx="0" cy="360040"/>
              </a:xfrm>
              <a:prstGeom prst="straightConnector1">
                <a:avLst/>
              </a:prstGeom>
              <a:ln>
                <a:solidFill>
                  <a:srgbClr val="92D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CaixaDeTexto 38"/>
              <p:cNvSpPr txBox="1"/>
              <p:nvPr/>
            </p:nvSpPr>
            <p:spPr>
              <a:xfrm>
                <a:off x="2738275" y="4221088"/>
                <a:ext cx="120898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6a+C3+C3*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41" name="Conexão recta unidireccional 40"/>
              <p:cNvCxnSpPr/>
              <p:nvPr/>
            </p:nvCxnSpPr>
            <p:spPr>
              <a:xfrm>
                <a:off x="3059832" y="4437112"/>
                <a:ext cx="0" cy="288032"/>
              </a:xfrm>
              <a:prstGeom prst="straightConnector1">
                <a:avLst/>
              </a:prstGeom>
              <a:ln>
                <a:solidFill>
                  <a:srgbClr val="92D05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CaixaDeTexto 43"/>
              <p:cNvSpPr txBox="1"/>
              <p:nvPr/>
            </p:nvSpPr>
            <p:spPr>
              <a:xfrm>
                <a:off x="3059832" y="4437112"/>
                <a:ext cx="6110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8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CaixaDeTexto 44"/>
              <p:cNvSpPr txBox="1"/>
              <p:nvPr/>
            </p:nvSpPr>
            <p:spPr>
              <a:xfrm>
                <a:off x="3203848" y="4622939"/>
                <a:ext cx="7008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dTC5+5*</a:t>
                </a:r>
                <a:endParaRPr lang="en-US" sz="1000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CaixaDeTexto 45"/>
              <p:cNvSpPr txBox="1"/>
              <p:nvPr/>
            </p:nvSpPr>
            <p:spPr>
              <a:xfrm>
                <a:off x="4139952" y="4293096"/>
                <a:ext cx="5357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dTC4’</a:t>
                </a:r>
                <a:endParaRPr lang="en-US" sz="1000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CaixaDeTexto 46"/>
              <p:cNvSpPr txBox="1"/>
              <p:nvPr/>
            </p:nvSpPr>
            <p:spPr>
              <a:xfrm>
                <a:off x="4427984" y="4437112"/>
                <a:ext cx="7665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dTC1’+1’*</a:t>
                </a:r>
                <a:endParaRPr lang="en-US" sz="1000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CaixaDeTexto 47"/>
              <p:cNvSpPr txBox="1"/>
              <p:nvPr/>
            </p:nvSpPr>
            <p:spPr>
              <a:xfrm>
                <a:off x="4664731" y="4581128"/>
                <a:ext cx="7713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dTC3’+3’*</a:t>
                </a:r>
                <a:endParaRPr lang="en-US" sz="1000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50" name="Conexão recta unidireccional 49"/>
              <p:cNvCxnSpPr/>
              <p:nvPr/>
            </p:nvCxnSpPr>
            <p:spPr>
              <a:xfrm flipH="1">
                <a:off x="4572000" y="4581128"/>
                <a:ext cx="72007" cy="216024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CaixaDeTexto 53"/>
              <p:cNvSpPr txBox="1"/>
              <p:nvPr/>
            </p:nvSpPr>
            <p:spPr>
              <a:xfrm>
                <a:off x="5240795" y="4478923"/>
                <a:ext cx="7713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dTC5’+5’*</a:t>
                </a:r>
                <a:endParaRPr lang="en-US" sz="1000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CaixaDeTexto 54"/>
              <p:cNvSpPr txBox="1"/>
              <p:nvPr/>
            </p:nvSpPr>
            <p:spPr>
              <a:xfrm>
                <a:off x="6228184" y="4005064"/>
                <a:ext cx="7713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dTC2’+2’*</a:t>
                </a:r>
                <a:endParaRPr lang="en-US" sz="1000" b="1" dirty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CaixaDeTexto 55"/>
              <p:cNvSpPr txBox="1"/>
              <p:nvPr/>
            </p:nvSpPr>
            <p:spPr>
              <a:xfrm>
                <a:off x="6228184" y="4437112"/>
                <a:ext cx="6815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12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CaixaDeTexto 56"/>
              <p:cNvSpPr txBox="1"/>
              <p:nvPr/>
            </p:nvSpPr>
            <p:spPr>
              <a:xfrm>
                <a:off x="6770723" y="4406915"/>
                <a:ext cx="6815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13</a:t>
                </a:r>
                <a:endParaRPr lang="en-US" sz="1000" b="1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CaixaDeTexto 57"/>
              <p:cNvSpPr txBox="1"/>
              <p:nvPr/>
            </p:nvSpPr>
            <p:spPr>
              <a:xfrm>
                <a:off x="7308569" y="4262899"/>
                <a:ext cx="5757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dTCH</a:t>
                </a:r>
                <a:r>
                  <a:rPr lang="en-US" sz="1000" b="1" baseline="-25000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3</a:t>
                </a:r>
                <a:endParaRPr lang="en-US" sz="1000" b="1" baseline="-25000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CaixaDeTexto 58"/>
              <p:cNvSpPr txBox="1"/>
              <p:nvPr/>
            </p:nvSpPr>
            <p:spPr>
              <a:xfrm>
                <a:off x="7778453" y="4365104"/>
                <a:ext cx="89800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solidFill>
                      <a:srgbClr val="00B050"/>
                    </a:solidFill>
                    <a:latin typeface="Arial" pitchFamily="34" charset="0"/>
                    <a:cs typeface="Arial" pitchFamily="34" charset="0"/>
                  </a:rPr>
                  <a:t>NVPC14+15</a:t>
                </a:r>
                <a:endParaRPr lang="en-US" sz="1000" b="1" baseline="-25000" dirty="0">
                  <a:solidFill>
                    <a:srgbClr val="00B05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1261351" y="1844824"/>
              <a:ext cx="2571750" cy="1499749"/>
              <a:chOff x="1261351" y="2217283"/>
              <a:chExt cx="2571750" cy="1499749"/>
            </a:xfrm>
          </p:grpSpPr>
          <p:pic>
            <p:nvPicPr>
              <p:cNvPr id="2055" name="Picture 7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1351" y="2217283"/>
                <a:ext cx="2571750" cy="14763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2266914" y="3378478"/>
                <a:ext cx="28886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PT" sz="1600" b="1" dirty="0"/>
                  <a:t>9</a:t>
                </a: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/>
          <p:cNvGrpSpPr/>
          <p:nvPr/>
        </p:nvGrpSpPr>
        <p:grpSpPr>
          <a:xfrm>
            <a:off x="942975" y="404664"/>
            <a:ext cx="7258050" cy="5586561"/>
            <a:chOff x="942975" y="404664"/>
            <a:chExt cx="7258050" cy="5586561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942975" y="866775"/>
              <a:ext cx="7258050" cy="51244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CaixaDeTexto 4"/>
            <p:cNvSpPr txBox="1"/>
            <p:nvPr/>
          </p:nvSpPr>
          <p:spPr>
            <a:xfrm>
              <a:off x="2195736" y="404664"/>
              <a:ext cx="44802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itchFamily="18" charset="0"/>
                  <a:cs typeface="Times New Roman" pitchFamily="18" charset="0"/>
                </a:rPr>
                <a:t>Figure S3.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HSQC</a:t>
              </a:r>
              <a:r>
                <a:rPr lang="en-US" sz="1600" baseline="30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spectrum</a:t>
              </a:r>
              <a:r>
                <a:rPr lang="en-US" sz="1600" baseline="30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of </a:t>
              </a:r>
              <a:r>
                <a:rPr lang="en-US" sz="1600" b="1" dirty="0" smtClean="0">
                  <a:latin typeface="Times New Roman" pitchFamily="18" charset="0"/>
                  <a:cs typeface="Times New Roman" pitchFamily="18" charset="0"/>
                </a:rPr>
                <a:t>9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recorded in </a:t>
              </a:r>
              <a:r>
                <a:rPr lang="en-US" sz="1600" dirty="0" err="1" smtClean="0">
                  <a:latin typeface="Times New Roman" pitchFamily="18" charset="0"/>
                  <a:cs typeface="Times New Roman" pitchFamily="18" charset="0"/>
                </a:rPr>
                <a:t>MeOD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o 6"/>
          <p:cNvGrpSpPr/>
          <p:nvPr/>
        </p:nvGrpSpPr>
        <p:grpSpPr>
          <a:xfrm>
            <a:off x="1419225" y="642174"/>
            <a:ext cx="6305550" cy="5010914"/>
            <a:chOff x="1419225" y="642174"/>
            <a:chExt cx="6305550" cy="5010914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419225" y="1204913"/>
              <a:ext cx="6305550" cy="44481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" name="CaixaDeTexto 3"/>
            <p:cNvSpPr txBox="1"/>
            <p:nvPr/>
          </p:nvSpPr>
          <p:spPr>
            <a:xfrm>
              <a:off x="2127586" y="642174"/>
              <a:ext cx="45379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 smtClean="0">
                  <a:latin typeface="Times New Roman" pitchFamily="18" charset="0"/>
                  <a:cs typeface="Times New Roman" pitchFamily="18" charset="0"/>
                </a:rPr>
                <a:t>Figure S4.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HMBC</a:t>
              </a:r>
              <a:r>
                <a:rPr lang="en-US" sz="1600" baseline="30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spectrum</a:t>
              </a:r>
              <a:r>
                <a:rPr lang="en-US" sz="1600" baseline="300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of </a:t>
              </a:r>
              <a:r>
                <a:rPr lang="en-US" sz="1600" b="1" dirty="0" smtClean="0">
                  <a:latin typeface="Times New Roman" pitchFamily="18" charset="0"/>
                  <a:cs typeface="Times New Roman" pitchFamily="18" charset="0"/>
                </a:rPr>
                <a:t>9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recorded in </a:t>
              </a:r>
              <a:r>
                <a:rPr lang="en-US" sz="1600" dirty="0" err="1" smtClean="0">
                  <a:latin typeface="Times New Roman" pitchFamily="18" charset="0"/>
                  <a:cs typeface="Times New Roman" pitchFamily="18" charset="0"/>
                </a:rPr>
                <a:t>MeOD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.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5" name="Marcador de Posição do Número do Diapositivo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5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6</a:t>
            </a:fld>
            <a:endParaRPr lang="en-US"/>
          </a:p>
        </p:txBody>
      </p:sp>
      <p:pic>
        <p:nvPicPr>
          <p:cNvPr id="3" name="Picture 2" descr="507_MS.jpg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2800350" y="1524000"/>
            <a:ext cx="3543300" cy="38100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915816" y="836712"/>
            <a:ext cx="304070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S5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ESI-MS spectrum of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9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42741943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7</a:t>
            </a:fld>
            <a:endParaRPr lang="en-US"/>
          </a:p>
        </p:txBody>
      </p:sp>
      <p:pic>
        <p:nvPicPr>
          <p:cNvPr id="3" name="Picture 2" descr="TIM_aduto_1.jpg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1843087" y="1509712"/>
            <a:ext cx="5457825" cy="383857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691680" y="836712"/>
            <a:ext cx="576064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S6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Tandem ESI-MS spectra of  the </a:t>
            </a:r>
            <a:r>
              <a:rPr lang="en-US" sz="1600" i="1" dirty="0">
                <a:latin typeface="Times New Roman" pitchFamily="18" charset="0"/>
                <a:cs typeface="Times New Roman" pitchFamily="18" charset="0"/>
              </a:rPr>
              <a:t>m/z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507 ion of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9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7191910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/>
          <p:cNvGrpSpPr/>
          <p:nvPr/>
        </p:nvGrpSpPr>
        <p:grpSpPr>
          <a:xfrm>
            <a:off x="1619672" y="1124744"/>
            <a:ext cx="5544616" cy="3923813"/>
            <a:chOff x="1331640" y="1124744"/>
            <a:chExt cx="5544616" cy="3923813"/>
          </a:xfrm>
        </p:grpSpPr>
        <p:sp>
          <p:nvSpPr>
            <p:cNvPr id="5" name="CaixaDeTexto 4"/>
            <p:cNvSpPr txBox="1"/>
            <p:nvPr/>
          </p:nvSpPr>
          <p:spPr>
            <a:xfrm>
              <a:off x="1907704" y="1124744"/>
              <a:ext cx="42397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itchFamily="18" charset="0"/>
                  <a:cs typeface="Times New Roman" pitchFamily="18" charset="0"/>
                </a:rPr>
                <a:t>Figure S7.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HPLC-DAD of </a:t>
              </a:r>
              <a:r>
                <a:rPr lang="en-US" sz="1600" b="1" dirty="0" smtClean="0">
                  <a:latin typeface="Times New Roman" pitchFamily="18" charset="0"/>
                  <a:cs typeface="Times New Roman" pitchFamily="18" charset="0"/>
                </a:rPr>
                <a:t>9 </a:t>
              </a:r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recorded at 254 nm.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331640" y="1988840"/>
              <a:ext cx="5544616" cy="30597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8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B69E74-BF3B-4550-B2E7-D5DC602379AC}" type="slidenum">
              <a:rPr lang="en-US" smtClean="0"/>
              <a:pPr/>
              <a:t>9</a:t>
            </a:fld>
            <a:endParaRPr lang="en-US"/>
          </a:p>
        </p:txBody>
      </p:sp>
      <p:pic>
        <p:nvPicPr>
          <p:cNvPr id="5" name="Picture 4" descr="TIM_aduto_min_c.jpg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2671762" y="1981200"/>
            <a:ext cx="3800475" cy="28956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691680" y="1124744"/>
            <a:ext cx="576064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S8.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Tandem ESI-MS spectra of  the </a:t>
            </a:r>
            <a:r>
              <a:rPr lang="en-US" sz="1600" i="1" dirty="0">
                <a:latin typeface="Times New Roman" pitchFamily="18" charset="0"/>
                <a:cs typeface="Times New Roman" pitchFamily="18" charset="0"/>
              </a:rPr>
              <a:t>m/z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507 ion of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10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5040846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6</TotalTime>
  <Words>199</Words>
  <Application>Microsoft Office PowerPoint</Application>
  <PresentationFormat>On-screen Show (4:3)</PresentationFormat>
  <Paragraphs>72</Paragraphs>
  <Slides>9</Slides>
  <Notes>9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Tema do Offic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Company>Instituto Superior Tecnic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o 1</dc:title>
  <dc:creator>Xana</dc:creator>
  <cp:lastModifiedBy>mdpi</cp:lastModifiedBy>
  <cp:revision>33</cp:revision>
  <cp:lastPrinted>2013-04-16T11:25:46Z</cp:lastPrinted>
  <dcterms:created xsi:type="dcterms:W3CDTF">2011-10-21T14:42:39Z</dcterms:created>
  <dcterms:modified xsi:type="dcterms:W3CDTF">2013-04-26T06:42:03Z</dcterms:modified>
</cp:coreProperties>
</file>